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85" r:id="rId2"/>
    <p:sldId id="286" r:id="rId3"/>
    <p:sldId id="287" r:id="rId4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4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95809"/>
    <a:srgbClr val="173671"/>
    <a:srgbClr val="A3672C"/>
    <a:srgbClr val="A5264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740" autoAdjust="0"/>
    <p:restoredTop sz="96311" autoAdjust="0"/>
  </p:normalViewPr>
  <p:slideViewPr>
    <p:cSldViewPr snapToGrid="0" showGuides="1">
      <p:cViewPr varScale="1">
        <p:scale>
          <a:sx n="86" d="100"/>
          <a:sy n="86" d="100"/>
        </p:scale>
        <p:origin x="4016" y="200"/>
      </p:cViewPr>
      <p:guideLst>
        <p:guide orient="horz" pos="3120"/>
        <p:guide pos="2144"/>
      </p:guideLst>
    </p:cSldViewPr>
  </p:slideViewPr>
  <p:notesTextViewPr>
    <p:cViewPr>
      <p:scale>
        <a:sx n="200" d="100"/>
        <a:sy n="2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B5B69A-FF6E-F74E-8656-7FB92AB50276}" type="datetimeFigureOut">
              <a:rPr kumimoji="1" lang="ja-JP" altLang="en-US" smtClean="0"/>
              <a:t>2026/1/19</a:t>
            </a:fld>
            <a:endParaRPr kumimoji="1" lang="ja-JP" altLang="en-US" dirty="0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 dirty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161CDDE-F516-544E-9105-AEF0674AD513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8950941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BA2ED0E-A886-AB3B-DBD4-62D690F0606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3A729D68-CC5D-3580-EE03-56452784891E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06F968E7-2066-A534-0724-B348EAB8B5CD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b="1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A901159-D859-8BC5-2E58-A3DB44EFB9DC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161CDDE-F516-544E-9105-AEF0674AD513}" type="slidenum">
              <a:rPr kumimoji="1" lang="ja-JP" altLang="en-US" smtClean="0"/>
              <a:t>1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6222874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BD82BCD-354B-AA47-829B-198D7615067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E0AB902C-5C5C-814F-92A7-8B2A64CD638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45BADB7-2DF9-A147-94AD-5011D4C770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9DD4A-7D5F-3E42-8F9E-F913EEC653A3}" type="datetimeFigureOut">
              <a:rPr kumimoji="1" lang="ja-JP" altLang="en-US" smtClean="0"/>
              <a:t>2026/1/19</a:t>
            </a:fld>
            <a:endParaRPr kumimoji="1" lang="ja-JP" altLang="en-US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1F99231-3DD4-BE4C-BB2E-00AB46CFCB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525E0A9-7C5B-654B-8F45-2421439F75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D34F8-2AD6-0E4F-935A-C5C3EAFEECD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6403435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58CC049-4897-274A-9002-F369FF6E2A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003F0EC-9063-B74C-86E8-69AA3B836C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17750BE-8D39-5140-B4FC-6E8032CA1E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9DD4A-7D5F-3E42-8F9E-F913EEC653A3}" type="datetimeFigureOut">
              <a:rPr kumimoji="1" lang="ja-JP" altLang="en-US" smtClean="0"/>
              <a:t>2026/1/19</a:t>
            </a:fld>
            <a:endParaRPr kumimoji="1" lang="ja-JP" altLang="en-US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38D791D-C993-8147-8A44-46299C0214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EBB66B4-8A3E-D342-BFC9-09148AD9C1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D34F8-2AD6-0E4F-935A-C5C3EAFEECD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6633641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1866DA1-6B9A-9F44-8C0C-500BAD1024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88C7EC9-192F-2641-B813-C30BB78B82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F30022D-1E0E-6F40-A1D2-1C09826185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9DD4A-7D5F-3E42-8F9E-F913EEC653A3}" type="datetimeFigureOut">
              <a:rPr kumimoji="1" lang="ja-JP" altLang="en-US" smtClean="0"/>
              <a:t>2026/1/19</a:t>
            </a:fld>
            <a:endParaRPr kumimoji="1" lang="ja-JP" altLang="en-US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553BF65-A45B-0C4E-922F-46179313A1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6906C79-4DD7-C04C-9D62-9224838689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D34F8-2AD6-0E4F-935A-C5C3EAFEECD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6920910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5EB28B0-3765-0E4E-97BD-022262AB28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61215DF-2C0A-034C-9579-387A933605B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BCDAC4B-A553-014B-85F2-00001419FA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9DD4A-7D5F-3E42-8F9E-F913EEC653A3}" type="datetimeFigureOut">
              <a:rPr kumimoji="1" lang="ja-JP" altLang="en-US" smtClean="0"/>
              <a:t>2026/1/19</a:t>
            </a:fld>
            <a:endParaRPr kumimoji="1" lang="ja-JP" altLang="en-US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66F9665-BF98-5E48-A75D-0892727ADC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922F554-69F7-DF40-BD53-0E349CE5BA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D34F8-2AD6-0E4F-935A-C5C3EAFEECD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4600348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C6BA69D-74E8-6F44-82BB-0501F4E4D5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7" y="2469622"/>
            <a:ext cx="5915025" cy="4120620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CA6FCB7-87C8-394F-BB07-3CF88D1AC7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D2687C6-22D6-A741-B212-7FF5BEDB12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9DD4A-7D5F-3E42-8F9E-F913EEC653A3}" type="datetimeFigureOut">
              <a:rPr kumimoji="1" lang="ja-JP" altLang="en-US" smtClean="0"/>
              <a:t>2026/1/19</a:t>
            </a:fld>
            <a:endParaRPr kumimoji="1" lang="ja-JP" altLang="en-US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954F039-5429-FD49-A14D-78783FA5C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6BFEEBE-938F-E84B-9D3C-735C2C8764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D34F8-2AD6-0E4F-935A-C5C3EAFEECD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500620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9BBB74A-5C57-7348-9489-688CA3B3B3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BDE21DB-5487-6246-B66A-F8F84C44A4F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29B2ADA-F34A-E54E-9846-CDEEC8828A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007D1D4-7EE9-6F4B-BA91-6888BE6069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9DD4A-7D5F-3E42-8F9E-F913EEC653A3}" type="datetimeFigureOut">
              <a:rPr kumimoji="1" lang="ja-JP" altLang="en-US" smtClean="0"/>
              <a:t>2026/1/19</a:t>
            </a:fld>
            <a:endParaRPr kumimoji="1" lang="ja-JP" altLang="en-US" dirty="0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75ABAAA-D81C-944C-929B-8321F5A32C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7543EEF-ABD8-AD4A-A375-E98F4A6DE9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D34F8-2AD6-0E4F-935A-C5C3EAFEECD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793068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CD0714F-6FE6-3648-B8D9-1A20CA7C75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2" y="527405"/>
            <a:ext cx="5915025" cy="1914702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6D43BC2-E811-C549-8838-18D6D79194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922D5ED-A5E8-6048-801C-CBAD5BB99D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C3E91A89-53D4-4C41-BFF5-4E13ED1004C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5C5BA90-BD25-5C44-A4CA-4F295B47C4D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392CE0D-A621-294A-9E34-3047087EF8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9DD4A-7D5F-3E42-8F9E-F913EEC653A3}" type="datetimeFigureOut">
              <a:rPr kumimoji="1" lang="ja-JP" altLang="en-US" smtClean="0"/>
              <a:t>2026/1/19</a:t>
            </a:fld>
            <a:endParaRPr kumimoji="1" lang="ja-JP" altLang="en-US" dirty="0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410D488-2935-464F-AD20-BA372EEF3F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68D4A731-8DD1-254F-8F60-E807DA69B0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D34F8-2AD6-0E4F-935A-C5C3EAFEECD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5881455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C9FB9C0-386A-7041-85E4-47166F80BE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C944BD7-47D4-C843-8C90-E761065FAD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9DD4A-7D5F-3E42-8F9E-F913EEC653A3}" type="datetimeFigureOut">
              <a:rPr kumimoji="1" lang="ja-JP" altLang="en-US" smtClean="0"/>
              <a:t>2026/1/19</a:t>
            </a:fld>
            <a:endParaRPr kumimoji="1" lang="ja-JP" altLang="en-US" dirty="0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72D7FCC6-6D94-A14F-A38D-FF5244C784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D9D0978-FD32-2C41-8948-03715AAB8D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D34F8-2AD6-0E4F-935A-C5C3EAFEECD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846568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640F4C4-CFB6-A842-B497-E11AEA6E4E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9DD4A-7D5F-3E42-8F9E-F913EEC653A3}" type="datetimeFigureOut">
              <a:rPr kumimoji="1" lang="ja-JP" altLang="en-US" smtClean="0"/>
              <a:t>2026/1/19</a:t>
            </a:fld>
            <a:endParaRPr kumimoji="1" lang="ja-JP" altLang="en-US" dirty="0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E862516-635F-254C-B03E-51EDEF8C88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D8E1173-9A59-EE4E-B7A8-04890C52FE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D34F8-2AD6-0E4F-935A-C5C3EAFEECD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3140727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F317831-5855-4446-AEB6-0288AFC72F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C941A92-60AC-7E4A-890C-A31DDBE75A0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4" y="1426282"/>
            <a:ext cx="3471863" cy="703968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778DEBC-1725-5240-AFF6-C23D9F07CB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6ECF310-E4FB-5941-A162-BC8B48BA30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9DD4A-7D5F-3E42-8F9E-F913EEC653A3}" type="datetimeFigureOut">
              <a:rPr kumimoji="1" lang="ja-JP" altLang="en-US" smtClean="0"/>
              <a:t>2026/1/19</a:t>
            </a:fld>
            <a:endParaRPr kumimoji="1" lang="ja-JP" altLang="en-US" dirty="0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8A2F6F0-DA42-E649-B0BC-743ED7D9EB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F554905-6D1B-C94D-ABE1-EF9376574D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D34F8-2AD6-0E4F-935A-C5C3EAFEECD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859785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6A32CCA-5D54-2D4D-85C0-E3598133BD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97299CCB-AD1B-E94D-AEB0-1F5AB6CD6E9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4" y="1426282"/>
            <a:ext cx="3471863" cy="7039681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kumimoji="1" lang="ja-JP" altLang="en-US" dirty="0"/>
              <a:t>アイコンをクリックして図を追加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687C302-AF6A-1744-8B5B-1D7B15B3BA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231B1E9-6EC7-264F-929D-0E63596DF2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9DD4A-7D5F-3E42-8F9E-F913EEC653A3}" type="datetimeFigureOut">
              <a:rPr kumimoji="1" lang="ja-JP" altLang="en-US" smtClean="0"/>
              <a:t>2026/1/19</a:t>
            </a:fld>
            <a:endParaRPr kumimoji="1" lang="ja-JP" altLang="en-US" dirty="0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C78DAD3-1A2E-F54E-BE0F-E2A12AACA8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0F12E39-BC84-CD40-B5D0-FC07ED769B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D34F8-2AD6-0E4F-935A-C5C3EAFEECD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255185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82A51EC6-8793-0D47-B314-AFEDD2568B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9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CEA475C-02C4-D744-92D3-364F5806AE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6F595B1-E1E9-BC4F-B89B-6AF2005DB73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  <a:latin typeface="Meiryo UI" panose="020B0604030504040204" pitchFamily="34" charset="-128"/>
                <a:ea typeface="Meiryo UI" panose="020B0604030504040204" pitchFamily="34" charset="-128"/>
              </a:defRPr>
            </a:lvl1pPr>
          </a:lstStyle>
          <a:p>
            <a:fld id="{E439DD4A-7D5F-3E42-8F9E-F913EEC653A3}" type="datetimeFigureOut">
              <a:rPr lang="ja-JP" altLang="en-US" smtClean="0"/>
              <a:pPr/>
              <a:t>2026/1/19</a:t>
            </a:fld>
            <a:endParaRPr lang="ja-JP" altLang="en-US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5EACE34-F28E-2E44-89C9-A8A0BEC1D28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  <a:latin typeface="Meiryo UI" panose="020B0604030504040204" pitchFamily="34" charset="-128"/>
                <a:ea typeface="Meiryo UI" panose="020B0604030504040204" pitchFamily="34" charset="-128"/>
              </a:defRPr>
            </a:lvl1pPr>
          </a:lstStyle>
          <a:p>
            <a:endParaRPr lang="ja-JP" altLang="en-US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10B57CE-8510-C14B-A7DF-7EABD1A91F5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  <a:latin typeface="Meiryo UI" panose="020B0604030504040204" pitchFamily="34" charset="-128"/>
                <a:ea typeface="Meiryo UI" panose="020B0604030504040204" pitchFamily="34" charset="-128"/>
              </a:defRPr>
            </a:lvl1pPr>
          </a:lstStyle>
          <a:p>
            <a:fld id="{78DD34F8-2AD6-0E4F-935A-C5C3EAFEECDF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8486334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Meiryo UI" panose="020B0604030504040204" pitchFamily="34" charset="-128"/>
          <a:ea typeface="Meiryo UI" panose="020B0604030504040204" pitchFamily="34" charset="-128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Meiryo UI" panose="020B0604030504040204" pitchFamily="34" charset="-128"/>
          <a:ea typeface="Meiryo UI" panose="020B0604030504040204" pitchFamily="34" charset="-128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Meiryo UI" panose="020B0604030504040204" pitchFamily="34" charset="-128"/>
          <a:ea typeface="Meiryo UI" panose="020B0604030504040204" pitchFamily="34" charset="-128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Meiryo UI" panose="020B0604030504040204" pitchFamily="34" charset="-128"/>
          <a:ea typeface="Meiryo UI" panose="020B0604030504040204" pitchFamily="34" charset="-128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Meiryo UI" panose="020B0604030504040204" pitchFamily="34" charset="-128"/>
          <a:ea typeface="Meiryo UI" panose="020B0604030504040204" pitchFamily="34" charset="-128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Meiryo UI" panose="020B0604030504040204" pitchFamily="34" charset="-128"/>
          <a:ea typeface="Meiryo UI" panose="020B0604030504040204" pitchFamily="34" charset="-128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3A49938-83A4-CF66-AA2E-D529C6ECD90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3432D77-511D-0C87-9715-7706F6D9A83E}"/>
              </a:ext>
            </a:extLst>
          </p:cNvPr>
          <p:cNvSpPr txBox="1"/>
          <p:nvPr/>
        </p:nvSpPr>
        <p:spPr>
          <a:xfrm>
            <a:off x="0" y="2289738"/>
            <a:ext cx="673768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 pitchFamily="2" charset="0"/>
              </a:rPr>
              <a:t>Supplementary Figure S1. Correlation between fibrinogen (Fg) level and CLySis assay parameters in normal plasma samples.</a:t>
            </a:r>
          </a:p>
          <a:p>
            <a:endParaRPr lang="en-US" altLang="ja-JP" sz="1200" dirty="0">
              <a:latin typeface="Helvetica" pitchFamily="2" charset="0"/>
            </a:endParaRPr>
          </a:p>
          <a:p>
            <a:r>
              <a:rPr lang="en-US" altLang="ja-JP" sz="1200" dirty="0">
                <a:latin typeface="Helvetica" pitchFamily="2" charset="0"/>
              </a:rPr>
              <a:t>Relationships between Fg:C and Vmax</a:t>
            </a:r>
            <a:r>
              <a:rPr lang="en-US" altLang="ja-JP" sz="1200" baseline="30000" dirty="0">
                <a:latin typeface="Helvetica" pitchFamily="2" charset="0"/>
              </a:rPr>
              <a:t>clot</a:t>
            </a:r>
            <a:r>
              <a:rPr lang="en-US" altLang="ja-JP" sz="1200" dirty="0">
                <a:latin typeface="Helvetica" pitchFamily="2" charset="0"/>
              </a:rPr>
              <a:t> (A) or T</a:t>
            </a:r>
            <a:r>
              <a:rPr lang="en-US" altLang="ja-JP" sz="1200" baseline="30000" dirty="0">
                <a:latin typeface="Helvetica" pitchFamily="2" charset="0"/>
              </a:rPr>
              <a:t>lysis</a:t>
            </a:r>
            <a:r>
              <a:rPr lang="en-US" altLang="ja-JP" sz="1200" dirty="0">
                <a:latin typeface="Helvetica" pitchFamily="2" charset="0"/>
              </a:rPr>
              <a:t> (B) or Vmax</a:t>
            </a:r>
            <a:r>
              <a:rPr lang="en-US" altLang="ja-JP" sz="1200" baseline="30000" dirty="0">
                <a:latin typeface="Helvetica" pitchFamily="2" charset="0"/>
              </a:rPr>
              <a:t>lysis</a:t>
            </a:r>
            <a:r>
              <a:rPr lang="en-US" altLang="ja-JP" sz="1200" dirty="0">
                <a:latin typeface="Helvetica" pitchFamily="2" charset="0"/>
              </a:rPr>
              <a:t> (C) in normal plasma samples (n = 50) shown with the coefficients of correlation (r).</a:t>
            </a:r>
            <a:endParaRPr lang="ja-JP" altLang="en-US" sz="1200" dirty="0">
              <a:latin typeface="Helvetica" pitchFamily="2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3A60C2F2-7BE3-763D-0CD5-DB665FBDF2C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0316" y="135514"/>
            <a:ext cx="2127798" cy="1946506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0B61C23-FF0B-1E1B-555C-3CE4EA083745}"/>
              </a:ext>
            </a:extLst>
          </p:cNvPr>
          <p:cNvSpPr txBox="1"/>
          <p:nvPr/>
        </p:nvSpPr>
        <p:spPr>
          <a:xfrm>
            <a:off x="-5904" y="8132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b="1" dirty="0">
                <a:latin typeface="Helvetica" pitchFamily="2" charset="0"/>
              </a:rPr>
              <a:t>A</a:t>
            </a:r>
            <a:endParaRPr kumimoji="1" lang="ja-JP" altLang="en-US" sz="1200" b="1" dirty="0">
              <a:latin typeface="Helvetica" pitchFamily="2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4628001-55B9-A48A-C5C1-4D7739E566AB}"/>
              </a:ext>
            </a:extLst>
          </p:cNvPr>
          <p:cNvSpPr txBox="1"/>
          <p:nvPr/>
        </p:nvSpPr>
        <p:spPr>
          <a:xfrm>
            <a:off x="2137184" y="8132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b="1" dirty="0">
                <a:latin typeface="Helvetica" pitchFamily="2" charset="0"/>
              </a:rPr>
              <a:t>B</a:t>
            </a:r>
            <a:endParaRPr kumimoji="1" lang="ja-JP" altLang="en-US" sz="1200" b="1" dirty="0">
              <a:latin typeface="Helvetica" pitchFamily="2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6C963E1-478A-5B45-7335-D6FB947D6336}"/>
              </a:ext>
            </a:extLst>
          </p:cNvPr>
          <p:cNvSpPr txBox="1"/>
          <p:nvPr/>
        </p:nvSpPr>
        <p:spPr>
          <a:xfrm>
            <a:off x="4357137" y="8132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ja-JP" sz="1200" b="1" dirty="0">
                <a:latin typeface="Helvetica" pitchFamily="2" charset="0"/>
              </a:rPr>
              <a:t>C</a:t>
            </a:r>
            <a:endParaRPr kumimoji="1" lang="ja-JP" altLang="en-US" sz="1200" b="1" dirty="0">
              <a:latin typeface="Helvetica" pitchFamily="2" charset="0"/>
            </a:endParaRP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5393065D-A7F3-C6AE-FDAA-3E6FEB67F8A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14049" y="135514"/>
            <a:ext cx="2165965" cy="1946506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537F4BF2-4A72-A77D-438E-6F7751EE171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56879" y="135514"/>
            <a:ext cx="2175507" cy="19465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075746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CFDBA96C-ED37-33E1-8732-297E4B8375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748" y="104930"/>
            <a:ext cx="5867400" cy="61468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9C62479-BD25-75F0-D8AD-3E80E1B9E5DB}"/>
              </a:ext>
            </a:extLst>
          </p:cNvPr>
          <p:cNvSpPr txBox="1"/>
          <p:nvPr/>
        </p:nvSpPr>
        <p:spPr>
          <a:xfrm>
            <a:off x="34758" y="6389708"/>
            <a:ext cx="673768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 pitchFamily="2" charset="0"/>
              </a:rPr>
              <a:t>Supplementary Figure S2. Plasmin generation assay.</a:t>
            </a:r>
          </a:p>
          <a:p>
            <a:endParaRPr lang="en-US" altLang="ja-JP" sz="1200" b="1" dirty="0">
              <a:latin typeface="Helvetica" pitchFamily="2" charset="0"/>
            </a:endParaRPr>
          </a:p>
          <a:p>
            <a:r>
              <a:rPr lang="en-US" altLang="ja-JP" sz="1200" dirty="0">
                <a:latin typeface="Helvetica" pitchFamily="2" charset="0"/>
              </a:rPr>
              <a:t>Absorbance at 405 nm was measured every 1 min, and the absorbance at 650 nm was subtracted from that at 405 nm </a:t>
            </a:r>
            <a:r>
              <a:rPr lang="en-US" altLang="ja-JP" sz="1200">
                <a:latin typeface="Helvetica" pitchFamily="2" charset="0"/>
              </a:rPr>
              <a:t>as background. </a:t>
            </a:r>
            <a:r>
              <a:rPr lang="en-US" altLang="ja-JP" sz="1200" dirty="0">
                <a:latin typeface="Helvetica" pitchFamily="2" charset="0"/>
              </a:rPr>
              <a:t>The dotted line indicates purified normal fibrinogen.</a:t>
            </a:r>
          </a:p>
        </p:txBody>
      </p:sp>
    </p:spTree>
    <p:extLst>
      <p:ext uri="{BB962C8B-B14F-4D97-AF65-F5344CB8AC3E}">
        <p14:creationId xmlns:p14="http://schemas.microsoft.com/office/powerpoint/2010/main" val="32156792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8831546-DF8F-63AB-D04F-8C63F65103C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BC374F0-8454-CE9A-C971-FDD70B05B1FD}"/>
              </a:ext>
            </a:extLst>
          </p:cNvPr>
          <p:cNvSpPr txBox="1"/>
          <p:nvPr/>
        </p:nvSpPr>
        <p:spPr>
          <a:xfrm>
            <a:off x="34758" y="6225684"/>
            <a:ext cx="673768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 pitchFamily="2" charset="0"/>
              </a:rPr>
              <a:t>Supplementary Figure S3. Kinetic analysis of tPA-mediated fibrinolysis in purified </a:t>
            </a:r>
            <a:r>
              <a:rPr lang="en-US" altLang="ja-JP" sz="1200" b="1" dirty="0" err="1">
                <a:latin typeface="Helvetica" pitchFamily="2" charset="0"/>
              </a:rPr>
              <a:t>dysfibrinogen</a:t>
            </a:r>
            <a:r>
              <a:rPr lang="en-US" altLang="ja-JP" sz="1200" b="1" dirty="0">
                <a:latin typeface="Helvetica" pitchFamily="2" charset="0"/>
              </a:rPr>
              <a:t> samples.</a:t>
            </a:r>
            <a:br>
              <a:rPr lang="en-US" altLang="ja-JP" sz="1200" b="1" dirty="0">
                <a:latin typeface="Helvetica" pitchFamily="2" charset="0"/>
              </a:rPr>
            </a:br>
            <a:endParaRPr lang="en-US" altLang="ja-JP" sz="1200" dirty="0">
              <a:latin typeface="Helvetica" pitchFamily="2" charset="0"/>
            </a:endParaRPr>
          </a:p>
          <a:p>
            <a:r>
              <a:rPr lang="en-US" altLang="ja-JP" sz="1200" dirty="0">
                <a:latin typeface="Helvetica" pitchFamily="2" charset="0"/>
              </a:rPr>
              <a:t>The percentage of lysis (%Lysis) was calculated as: %Lysis = 100 − (A405 × 100) / maximum A405. The dotted line indicates purified normal fibrinogen.</a:t>
            </a:r>
          </a:p>
          <a:p>
            <a:endParaRPr lang="en-US" altLang="ja-JP" sz="1200" b="1" dirty="0">
              <a:latin typeface="Helvetica" pitchFamily="2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5733B25C-73D6-AEE3-3D62-1E865F7B23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558" y="66184"/>
            <a:ext cx="6197600" cy="6159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58621134"/>
      </p:ext>
    </p:extLst>
  </p:cSld>
  <p:clrMapOvr>
    <a:masterClrMapping/>
  </p:clrMapOvr>
</p:sld>
</file>

<file path=ppt/theme/theme1.xml><?xml version="1.0" encoding="utf-8"?>
<a:theme xmlns:a="http://schemas.openxmlformats.org/drawingml/2006/main" name="blank">
  <a:themeElements>
    <a:clrScheme name="Figur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002F70"/>
      </a:accent1>
      <a:accent2>
        <a:srgbClr val="005A9C"/>
      </a:accent2>
      <a:accent3>
        <a:srgbClr val="0085C8"/>
      </a:accent3>
      <a:accent4>
        <a:srgbClr val="FF6862"/>
      </a:accent4>
      <a:accent5>
        <a:srgbClr val="FF998E"/>
      </a:accent5>
      <a:accent6>
        <a:srgbClr val="FFCCC3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 algn="l">
          <a:defRPr sz="1400" dirty="0" smtClean="0">
            <a:latin typeface="Helvetica" pitchFamily="2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blank" id="{E29BB6B1-CBAC-584C-BA53-22EF6E9F88E4}" vid="{E91B7E18-6742-9546-B6B3-6E116689A5B0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84515</TotalTime>
  <Words>152</Words>
  <Application>Microsoft Macintosh PowerPoint</Application>
  <PresentationFormat>A4 210 x 297 mm</PresentationFormat>
  <Paragraphs>12</Paragraphs>
  <Slides>3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Meiryo UI</vt:lpstr>
      <vt:lpstr>游ゴシック</vt:lpstr>
      <vt:lpstr>Arial</vt:lpstr>
      <vt:lpstr>Helvetica</vt:lpstr>
      <vt:lpstr>blank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Atsuo Suzuki</cp:lastModifiedBy>
  <cp:revision>79</cp:revision>
  <dcterms:created xsi:type="dcterms:W3CDTF">2024-08-17T05:18:18Z</dcterms:created>
  <dcterms:modified xsi:type="dcterms:W3CDTF">2026-01-19T01:30:42Z</dcterms:modified>
</cp:coreProperties>
</file>